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2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2" r:id="rId38"/>
    <p:sldId id="293" r:id="rId39"/>
    <p:sldId id="294" r:id="rId40"/>
    <p:sldId id="295" r:id="rId41"/>
  </p:sldIdLst>
  <p:sldSz cx="9144000" cy="6858000" type="screen4x3"/>
  <p:notesSz cx="6858000" cy="92964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28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46" roundtripDataSignature="AMtx7mieGdaq6yvlKAFCaxV+PaAKlTASA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94694"/>
  </p:normalViewPr>
  <p:slideViewPr>
    <p:cSldViewPr snapToGrid="0">
      <p:cViewPr>
        <p:scale>
          <a:sx n="94" d="100"/>
          <a:sy n="94" d="100"/>
        </p:scale>
        <p:origin x="1600" y="6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00" d="100"/>
          <a:sy n="100" d="100"/>
        </p:scale>
        <p:origin x="0" y="0"/>
      </p:cViewPr>
      <p:guideLst>
        <p:guide orient="horz" pos="2928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notesMaster" Target="notesMasters/notesMaster1.xml"/><Relationship Id="rId47" Type="http://schemas.openxmlformats.org/officeDocument/2006/relationships/presProps" Target="presProps.xml"/><Relationship Id="rId50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8" Type="http://schemas.openxmlformats.org/officeDocument/2006/relationships/viewProps" Target="viewProps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customschemas.google.com/relationships/presentationmetadata" Target="metadata"/><Relationship Id="rId20" Type="http://schemas.openxmlformats.org/officeDocument/2006/relationships/slide" Target="slides/slide19.xml"/><Relationship Id="rId41" Type="http://schemas.openxmlformats.org/officeDocument/2006/relationships/slide" Target="slides/slide4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L="457200" marR="0" lvl="0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36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</p:sp>
      <p:sp>
        <p:nvSpPr>
          <p:cNvPr id="67" name="Google Shape;67;p1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INTRODUCE AND READ TITLE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r>
              <a:rPr lang="en-US"/>
              <a:t>10 MINUTES TOTAL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8" name="Google Shape;68;p1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10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0" name="Google Shape;140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48" name="Google Shape;148;p11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Position of comfort and opens airway to improve patency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9" name="Google Shape;149;p11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1</a:t>
            </a:fld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Google Shape;156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57" name="Google Shape;157;p12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8" name="Google Shape;158;p12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2</a:t>
            </a:fld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Google Shape;165;p13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6" name="Google Shape;166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p14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75" name="Google Shape;175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Google Shape;182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83" name="Google Shape;183;p15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Will go through each of these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4" name="Google Shape;184;p15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5</a:t>
            </a:fld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Google Shape;191;p16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2" name="Google Shape;192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Google Shape;197;p17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8" name="Google Shape;198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Google Shape;205;p18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06" name="Google Shape;206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Google Shape;213;p19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4" name="Google Shape;214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4" name="Google Shape;74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p20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20" name="Google Shape;220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Google Shape;228;p21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29" name="Google Shape;229;p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Google Shape;236;p22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37" name="Google Shape;237;p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Google Shape;244;p23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45" name="Google Shape;245;p2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Google Shape;250;p24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51" name="Google Shape;251;p2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Google Shape;256;p2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57" name="Google Shape;257;p25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Caution in children who are malnourished or you are concerned are in heart failure or have a heart problem</a:t>
            </a:r>
            <a:endParaRPr/>
          </a:p>
        </p:txBody>
      </p:sp>
      <p:sp>
        <p:nvSpPr>
          <p:cNvPr id="258" name="Google Shape;258;p25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5</a:t>
            </a:fld>
            <a:endParaRPr/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Google Shape;263;p26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64" name="Google Shape;264;p2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Google Shape;271;p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72" name="Google Shape;272;p27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‘A’ stands for Alert:</a:t>
            </a:r>
            <a:r>
              <a:rPr lang="en-US" sz="1200" b="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n this state, the patient is fully awake and alert. Though neurologically patient may not respond normally, but they can respond to your voices and follow commands given by first responders.</a:t>
            </a:r>
            <a:endParaRPr dirty="0"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‘V’ stands for Voice:</a:t>
            </a:r>
            <a:r>
              <a:rPr lang="en-US" sz="1200" b="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t may happen that the victim is not alert but you can get them to open their eyes. If the injured person obeys a command given by you or is able to speak to you, then you can say that they are responsive to voice.</a:t>
            </a:r>
            <a:endParaRPr dirty="0"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‘P’ stands for Pain:</a:t>
            </a:r>
            <a:r>
              <a:rPr lang="en-US" sz="1200" b="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n this state, the victim doesn’t talk or respond to your voice. They only respond to a pain stimulus when you try pinching him/her.</a:t>
            </a:r>
            <a:endParaRPr dirty="0"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‘U’ stands for unresponsive:</a:t>
            </a:r>
            <a:r>
              <a:rPr lang="en-US" sz="1200" b="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f the patient is not showing any voice or motor response to your voice or pain stimulus, then they are completely unconscious.</a:t>
            </a:r>
            <a:endParaRPr dirty="0"/>
          </a:p>
        </p:txBody>
      </p:sp>
      <p:sp>
        <p:nvSpPr>
          <p:cNvPr id="273" name="Google Shape;273;p27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7</a:t>
            </a:fld>
            <a:endParaRPr/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Google Shape;280;p28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81" name="Google Shape;281;p28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8" name="Google Shape;288;p29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89" name="Google Shape;289;p29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3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Google Shape;296;p30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97" name="Google Shape;297;p3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4" name="Google Shape;304;p31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05" name="Google Shape;305;p3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2" name="Google Shape;312;p32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13" name="Google Shape;313;p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Google Shape;320;p33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21" name="Google Shape;321;p3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Google Shape;328;p34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29" name="Google Shape;329;p3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Google Shape;336;p35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37" name="Google Shape;337;p3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Google Shape;344;p36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45" name="Google Shape;345;p3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2" name="Google Shape;352;p37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53" name="Google Shape;353;p3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Google Shape;360;p38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61" name="Google Shape;361;p38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" name="Google Shape;368;p39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69" name="Google Shape;369;p39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8" name="Google Shape;88;p4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As you get a response call and are en route…</a:t>
            </a:r>
            <a:endParaRPr/>
          </a:p>
        </p:txBody>
      </p:sp>
      <p:sp>
        <p:nvSpPr>
          <p:cNvPr id="89" name="Google Shape;89;p4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4</a:t>
            </a:fld>
            <a:endParaRPr/>
          </a:p>
        </p:txBody>
      </p:sp>
    </p:spTree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Google Shape;376;p40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7" name="Google Shape;377;p4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7" name="Google Shape;97;p5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Pediatric Assessment Triangle- write out on easel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8" name="Google Shape;98;p5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5</a:t>
            </a:fld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6" name="Google Shape;106;p6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This incorporates all auditory and visual clues as you approach a scene- done in seconds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r>
              <a:rPr lang="en-US"/>
              <a:t>General impression of adult or pediatric patient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r>
              <a:rPr lang="en-US"/>
              <a:t>-Environment/ scene clues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r>
              <a:rPr lang="en-US"/>
              <a:t>-Look/Listen/Smell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r>
              <a:rPr lang="en-US"/>
              <a:t>-Obvious life threats?</a:t>
            </a:r>
            <a:endParaRPr/>
          </a:p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7" name="Google Shape;107;p6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6</a:t>
            </a:fld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7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5" name="Google Shape;115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23" name="Google Shape;123;p8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TICLS pneumonic</a:t>
            </a:r>
            <a:endParaRPr/>
          </a:p>
        </p:txBody>
      </p:sp>
      <p:sp>
        <p:nvSpPr>
          <p:cNvPr id="124" name="Google Shape;124;p8:notes"/>
          <p:cNvSpPr txBox="1">
            <a:spLocks noGrp="1"/>
          </p:cNvSpPr>
          <p:nvPr>
            <p:ph type="sldNum" idx="12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8</a:t>
            </a:fld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9:notes"/>
          <p:cNvSpPr txBox="1">
            <a:spLocks noGrp="1"/>
          </p:cNvSpPr>
          <p:nvPr>
            <p:ph type="body" idx="1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36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2" name="Google Shape;132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42"/>
          <p:cNvSpPr/>
          <p:nvPr/>
        </p:nvSpPr>
        <p:spPr>
          <a:xfrm>
            <a:off x="0" y="318052"/>
            <a:ext cx="9144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5" name="Google Shape;25;p42"/>
          <p:cNvSpPr txBox="1">
            <a:spLocks noGrp="1"/>
          </p:cNvSpPr>
          <p:nvPr>
            <p:ph type="ctrTitle"/>
          </p:nvPr>
        </p:nvSpPr>
        <p:spPr>
          <a:xfrm>
            <a:off x="3429000" y="609600"/>
            <a:ext cx="5715000" cy="350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sz="4400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26" name="Google Shape;26;p42"/>
          <p:cNvSpPr txBox="1">
            <a:spLocks noGrp="1"/>
          </p:cNvSpPr>
          <p:nvPr>
            <p:ph type="subTitle" idx="1"/>
          </p:nvPr>
        </p:nvSpPr>
        <p:spPr>
          <a:xfrm>
            <a:off x="3429000" y="3445933"/>
            <a:ext cx="5715000" cy="182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ctr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/>
            </a:lvl2pPr>
            <a:lvl3pPr lvl="2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/>
            </a:lvl3pPr>
            <a:lvl4pPr lvl="3" algn="ctr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/>
            </a:lvl4pPr>
            <a:lvl5pPr lvl="4" algn="ctr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/>
            </a:lvl5pPr>
            <a:lvl6pPr lvl="5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/>
            </a:lvl6pPr>
            <a:lvl7pPr lvl="6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/>
            </a:lvl7pPr>
            <a:lvl8pPr lvl="7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/>
            </a:lvl8pPr>
            <a:lvl9pPr lvl="8" algn="ctr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43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3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9pPr>
          </a:lstStyle>
          <a:p>
            <a:endParaRPr/>
          </a:p>
        </p:txBody>
      </p:sp>
      <p:sp>
        <p:nvSpPr>
          <p:cNvPr id="31" name="Google Shape;31;p43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43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43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44"/>
          <p:cNvSpPr/>
          <p:nvPr/>
        </p:nvSpPr>
        <p:spPr>
          <a:xfrm>
            <a:off x="1905000" y="1905000"/>
            <a:ext cx="6324600" cy="76200"/>
          </a:xfrm>
          <a:prstGeom prst="rect">
            <a:avLst/>
          </a:prstGeom>
          <a:gradFill>
            <a:gsLst>
              <a:gs pos="0">
                <a:srgbClr val="003399"/>
              </a:gs>
              <a:gs pos="100000">
                <a:srgbClr val="FFFFFF"/>
              </a:gs>
            </a:gsLst>
            <a:lin ang="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" name="Google Shape;36;p44"/>
          <p:cNvSpPr txBox="1">
            <a:spLocks noGrp="1"/>
          </p:cNvSpPr>
          <p:nvPr>
            <p:ph type="title"/>
          </p:nvPr>
        </p:nvSpPr>
        <p:spPr>
          <a:xfrm>
            <a:off x="1905000" y="381000"/>
            <a:ext cx="6324600" cy="136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 sz="4000" b="1" cap="none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44"/>
          <p:cNvSpPr txBox="1">
            <a:spLocks noGrp="1"/>
          </p:cNvSpPr>
          <p:nvPr>
            <p:ph type="body" idx="1"/>
          </p:nvPr>
        </p:nvSpPr>
        <p:spPr>
          <a:xfrm>
            <a:off x="1905000" y="2286000"/>
            <a:ext cx="6361113" cy="585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/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 sz="1800"/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None/>
              <a:defRPr sz="1600"/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9pPr>
          </a:lstStyle>
          <a:p>
            <a:endParaRPr/>
          </a:p>
        </p:txBody>
      </p:sp>
      <p:sp>
        <p:nvSpPr>
          <p:cNvPr id="38" name="Google Shape;38;p44"/>
          <p:cNvSpPr txBox="1">
            <a:spLocks noGrp="1"/>
          </p:cNvSpPr>
          <p:nvPr>
            <p:ph type="body" idx="2"/>
          </p:nvPr>
        </p:nvSpPr>
        <p:spPr>
          <a:xfrm>
            <a:off x="1905000" y="3276600"/>
            <a:ext cx="6361113" cy="585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/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 sz="1800"/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None/>
              <a:defRPr sz="1600"/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9pPr>
          </a:lstStyle>
          <a:p>
            <a:endParaRPr/>
          </a:p>
        </p:txBody>
      </p:sp>
      <p:sp>
        <p:nvSpPr>
          <p:cNvPr id="39" name="Google Shape;39;p44"/>
          <p:cNvSpPr txBox="1">
            <a:spLocks noGrp="1"/>
          </p:cNvSpPr>
          <p:nvPr>
            <p:ph type="body" idx="3"/>
          </p:nvPr>
        </p:nvSpPr>
        <p:spPr>
          <a:xfrm>
            <a:off x="1905000" y="4291013"/>
            <a:ext cx="6361113" cy="585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/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 sz="1800"/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None/>
              <a:defRPr sz="1600"/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  <a:defRPr sz="1400"/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/>
            </a:lvl9pPr>
          </a:lstStyle>
          <a:p>
            <a:endParaRPr/>
          </a:p>
        </p:txBody>
      </p:sp>
      <p:sp>
        <p:nvSpPr>
          <p:cNvPr id="40" name="Google Shape;40;p44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44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44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45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45"/>
          <p:cNvSpPr txBox="1">
            <a:spLocks noGrp="1"/>
          </p:cNvSpPr>
          <p:nvPr>
            <p:ph type="body" idx="1"/>
          </p:nvPr>
        </p:nvSpPr>
        <p:spPr>
          <a:xfrm>
            <a:off x="1676400" y="1981200"/>
            <a:ext cx="38100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Char char="»"/>
              <a:defRPr sz="16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9pPr>
          </a:lstStyle>
          <a:p>
            <a:endParaRPr/>
          </a:p>
        </p:txBody>
      </p:sp>
      <p:sp>
        <p:nvSpPr>
          <p:cNvPr id="46" name="Google Shape;46;p45"/>
          <p:cNvSpPr txBox="1">
            <a:spLocks noGrp="1"/>
          </p:cNvSpPr>
          <p:nvPr>
            <p:ph type="body" idx="2"/>
          </p:nvPr>
        </p:nvSpPr>
        <p:spPr>
          <a:xfrm>
            <a:off x="5181600" y="1981200"/>
            <a:ext cx="38100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Calibri"/>
              <a:buChar char="»"/>
              <a:defRPr sz="16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/>
            </a:lvl9pPr>
          </a:lstStyle>
          <a:p>
            <a:endParaRPr/>
          </a:p>
        </p:txBody>
      </p:sp>
      <p:sp>
        <p:nvSpPr>
          <p:cNvPr id="47" name="Google Shape;47;p45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45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45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46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46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46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46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None/>
              <a:defRPr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47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7" name="Google Shape;57;p47"/>
          <p:cNvSpPr/>
          <p:nvPr/>
        </p:nvSpPr>
        <p:spPr>
          <a:xfrm>
            <a:off x="228600" y="4876800"/>
            <a:ext cx="8686800" cy="1981200"/>
          </a:xfrm>
          <a:prstGeom prst="rect">
            <a:avLst/>
          </a:prstGeom>
          <a:gradFill>
            <a:gsLst>
              <a:gs pos="0">
                <a:srgbClr val="FFFFFF"/>
              </a:gs>
              <a:gs pos="100000">
                <a:srgbClr val="003E7E"/>
              </a:gs>
            </a:gsLst>
            <a:lin ang="540000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8" name="Google Shape;58;p47"/>
          <p:cNvSpPr/>
          <p:nvPr/>
        </p:nvSpPr>
        <p:spPr>
          <a:xfrm>
            <a:off x="8915400" y="4648200"/>
            <a:ext cx="228600" cy="2209800"/>
          </a:xfrm>
          <a:prstGeom prst="rect">
            <a:avLst/>
          </a:prstGeom>
          <a:gradFill>
            <a:gsLst>
              <a:gs pos="0">
                <a:srgbClr val="621B4B"/>
              </a:gs>
              <a:gs pos="100000">
                <a:srgbClr val="FFFFFF"/>
              </a:gs>
            </a:gsLst>
            <a:lin ang="1650000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9" name="Google Shape;59;p47"/>
          <p:cNvSpPr/>
          <p:nvPr/>
        </p:nvSpPr>
        <p:spPr>
          <a:xfrm rot="10800000">
            <a:off x="228600" y="0"/>
            <a:ext cx="8686800" cy="1905000"/>
          </a:xfrm>
          <a:prstGeom prst="rect">
            <a:avLst/>
          </a:prstGeom>
          <a:gradFill>
            <a:gsLst>
              <a:gs pos="0">
                <a:srgbClr val="FFFFFF"/>
              </a:gs>
              <a:gs pos="100000">
                <a:srgbClr val="003E7E"/>
              </a:gs>
            </a:gsLst>
            <a:lin ang="540000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0" name="Google Shape;60;p47"/>
          <p:cNvSpPr/>
          <p:nvPr/>
        </p:nvSpPr>
        <p:spPr>
          <a:xfrm rot="10800000">
            <a:off x="8915400" y="0"/>
            <a:ext cx="228600" cy="2209800"/>
          </a:xfrm>
          <a:prstGeom prst="rect">
            <a:avLst/>
          </a:prstGeom>
          <a:gradFill>
            <a:gsLst>
              <a:gs pos="0">
                <a:srgbClr val="621B4B"/>
              </a:gs>
              <a:gs pos="100000">
                <a:srgbClr val="FFFFFF"/>
              </a:gs>
            </a:gsLst>
            <a:lin ang="1650000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1" name="Google Shape;61;p47"/>
          <p:cNvSpPr/>
          <p:nvPr/>
        </p:nvSpPr>
        <p:spPr>
          <a:xfrm>
            <a:off x="12700" y="4648200"/>
            <a:ext cx="228600" cy="2209800"/>
          </a:xfrm>
          <a:prstGeom prst="rect">
            <a:avLst/>
          </a:prstGeom>
          <a:gradFill>
            <a:gsLst>
              <a:gs pos="0">
                <a:srgbClr val="621B4B"/>
              </a:gs>
              <a:gs pos="100000">
                <a:srgbClr val="FFFFFF"/>
              </a:gs>
            </a:gsLst>
            <a:lin ang="1650000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2" name="Google Shape;62;p47"/>
          <p:cNvSpPr/>
          <p:nvPr/>
        </p:nvSpPr>
        <p:spPr>
          <a:xfrm rot="10800000">
            <a:off x="12700" y="0"/>
            <a:ext cx="228600" cy="2209800"/>
          </a:xfrm>
          <a:prstGeom prst="rect">
            <a:avLst/>
          </a:prstGeom>
          <a:gradFill>
            <a:gsLst>
              <a:gs pos="0">
                <a:srgbClr val="621B4B"/>
              </a:gs>
              <a:gs pos="100000">
                <a:srgbClr val="FFFFFF"/>
              </a:gs>
            </a:gsLst>
            <a:lin ang="16500000" scaled="0"/>
          </a:gra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63" name="Google Shape;63;p47" descr="TCH_V_CMYK.eps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4876800" y="2514600"/>
            <a:ext cx="2493963" cy="1638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4" name="Google Shape;64;p4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33600" y="2381250"/>
            <a:ext cx="1819275" cy="21145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41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3600" b="1" i="0" u="none" strike="noStrike" cap="none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4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41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41"/>
          <p:cNvSpPr txBox="1">
            <a:spLocks noGrp="1"/>
          </p:cNvSpPr>
          <p:nvPr>
            <p:ph type="dt" idx="10"/>
          </p:nvPr>
        </p:nvSpPr>
        <p:spPr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Google Shape;13;p41"/>
          <p:cNvSpPr txBox="1">
            <a:spLocks noGrp="1"/>
          </p:cNvSpPr>
          <p:nvPr>
            <p:ph type="ftr" idx="11"/>
          </p:nvPr>
        </p:nvSpPr>
        <p:spPr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Google Shape;14;p41"/>
          <p:cNvSpPr txBox="1">
            <a:spLocks noGrp="1"/>
          </p:cNvSpPr>
          <p:nvPr>
            <p:ph type="sldNum" idx="12"/>
          </p:nvPr>
        </p:nvSpPr>
        <p:spPr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marR="0" lvl="0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spcAft>
                <a:spcPts val="0"/>
              </a:spcAft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jetem.org/peds_retractions/" TargetMode="External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peppsite.com" TargetMode="Externa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1"/>
          <p:cNvSpPr txBox="1">
            <a:spLocks noGrp="1"/>
          </p:cNvSpPr>
          <p:nvPr>
            <p:ph type="ctrTitle"/>
          </p:nvPr>
        </p:nvSpPr>
        <p:spPr>
          <a:xfrm>
            <a:off x="1714500" y="772551"/>
            <a:ext cx="5715000" cy="350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EMS- Pediatric Assessment</a:t>
            </a:r>
            <a:endParaRPr dirty="0"/>
          </a:p>
        </p:txBody>
      </p:sp>
      <p:sp>
        <p:nvSpPr>
          <p:cNvPr id="71" name="Google Shape;71;p1"/>
          <p:cNvSpPr txBox="1">
            <a:spLocks noGrp="1"/>
          </p:cNvSpPr>
          <p:nvPr>
            <p:ph type="subTitle" idx="1"/>
          </p:nvPr>
        </p:nvSpPr>
        <p:spPr>
          <a:xfrm>
            <a:off x="1714500" y="4277751"/>
            <a:ext cx="5715000" cy="599153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r>
              <a:rPr lang="en-US" b="1" i="1">
                <a:latin typeface="Calibri"/>
                <a:ea typeface="Calibri"/>
                <a:cs typeface="Calibri"/>
                <a:sym typeface="Calibri"/>
              </a:rPr>
              <a:t>Enter Date Here</a:t>
            </a:r>
            <a:endParaRPr sz="2000" i="1"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ctr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ctr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</a:pPr>
            <a:r>
              <a:rPr lang="en-US" sz="2000" b="1">
                <a:latin typeface="Calibri"/>
                <a:ea typeface="Calibri"/>
                <a:cs typeface="Calibri"/>
                <a:sym typeface="Calibri"/>
              </a:rPr>
              <a:t> </a:t>
            </a:r>
            <a:endParaRPr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6DB49B0-670A-1A46-B26C-290B65F0C476}"/>
              </a:ext>
            </a:extLst>
          </p:cNvPr>
          <p:cNvSpPr/>
          <p:nvPr/>
        </p:nvSpPr>
        <p:spPr>
          <a:xfrm>
            <a:off x="0" y="0"/>
            <a:ext cx="9144000" cy="7146388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25E4285-5E8E-304B-9D5D-A8691F0D6A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0344" y="6476323"/>
            <a:ext cx="1422400" cy="4826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p10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Breathing</a:t>
            </a:r>
            <a:endParaRPr/>
          </a:p>
        </p:txBody>
      </p:sp>
      <p:sp>
        <p:nvSpPr>
          <p:cNvPr id="143" name="Google Shape;143;p10"/>
          <p:cNvSpPr txBox="1">
            <a:spLocks noGrp="1"/>
          </p:cNvSpPr>
          <p:nvPr>
            <p:ph type="body" idx="1"/>
          </p:nvPr>
        </p:nvSpPr>
        <p:spPr>
          <a:xfrm>
            <a:off x="1680029" y="1923146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r>
              <a:rPr lang="en-US"/>
              <a:t>Abnormal sounds: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Upper airway obstruction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Snoring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Muffled      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Stridor</a:t>
            </a:r>
            <a:endParaRPr/>
          </a:p>
          <a:p>
            <a:pPr marL="0" lvl="0" indent="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Lower airway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Grunting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Wheezing</a:t>
            </a:r>
            <a:endParaRPr/>
          </a:p>
          <a:p>
            <a:pPr marL="0" lvl="0" indent="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34A513E-4123-EE4A-8736-B32D5875CFF4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Google Shape;151;p11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Breathing/Sniffing</a:t>
            </a:r>
            <a:br>
              <a:rPr lang="en-US" sz="4000"/>
            </a:br>
            <a:r>
              <a:rPr lang="en-US" sz="4000"/>
              <a:t>Position</a:t>
            </a:r>
            <a:endParaRPr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E65FEA7-1421-2746-8662-50CF03A7240F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5A3051-BEA5-7846-8810-43C567E5411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7" name="Picture 6" descr="A picture containing indoor, bed, window&#10;&#10;Description automatically generated">
            <a:extLst>
              <a:ext uri="{FF2B5EF4-FFF2-40B4-BE49-F238E27FC236}">
                <a16:creationId xmlns:a16="http://schemas.microsoft.com/office/drawing/2014/main" id="{BB4E24D8-5982-9943-BBEB-049B336B99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02128" y="1563914"/>
            <a:ext cx="3539743" cy="4913086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Google Shape;160;p12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Breathing/ Retractions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F37AA7-1D46-E64B-BA58-23ABF0C5DF2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14300" indent="0">
              <a:buNone/>
            </a:pPr>
            <a:r>
              <a:rPr lang="en-US" dirty="0"/>
              <a:t>For video of retractions go here:</a:t>
            </a:r>
          </a:p>
          <a:p>
            <a:pPr marL="114300" indent="0">
              <a:buNone/>
            </a:pPr>
            <a:r>
              <a:rPr lang="en-US" dirty="0">
                <a:hlinkClick r:id="rId3"/>
              </a:rPr>
              <a:t>https://jetem.org/peds_retractions</a:t>
            </a:r>
            <a:r>
              <a:rPr lang="en-US">
                <a:hlinkClick r:id="rId3"/>
              </a:rPr>
              <a:t>/</a:t>
            </a:r>
            <a:endParaRPr lang="en-US"/>
          </a:p>
          <a:p>
            <a:pPr marL="114300" indent="0">
              <a:buNone/>
            </a:pPr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1CEBE3D-3DA8-E148-AA58-51879DB47A82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E6BDE81-7B27-EB42-91CD-CD85819A3A7C}"/>
              </a:ext>
            </a:extLst>
          </p:cNvPr>
          <p:cNvSpPr txBox="1"/>
          <p:nvPr/>
        </p:nvSpPr>
        <p:spPr>
          <a:xfrm>
            <a:off x="3200400" y="2701636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p13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Circulation</a:t>
            </a:r>
            <a:endParaRPr/>
          </a:p>
        </p:txBody>
      </p:sp>
      <p:sp>
        <p:nvSpPr>
          <p:cNvPr id="169" name="Google Shape;169;p13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Pallor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Mottling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Cyanosis</a:t>
            </a:r>
            <a:endParaRPr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8FDE848-3EC9-E14E-AF92-3F86CAAFC7E0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Google Shape;177;p14"/>
          <p:cNvSpPr txBox="1">
            <a:spLocks noGrp="1"/>
          </p:cNvSpPr>
          <p:nvPr>
            <p:ph type="title"/>
          </p:nvPr>
        </p:nvSpPr>
        <p:spPr>
          <a:xfrm>
            <a:off x="1560286" y="314094"/>
            <a:ext cx="6897914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 dirty="0"/>
              <a:t>Primary Assessment- Hands On</a:t>
            </a:r>
            <a:endParaRPr dirty="0"/>
          </a:p>
        </p:txBody>
      </p:sp>
      <p:pic>
        <p:nvPicPr>
          <p:cNvPr id="180" name="Google Shape;180;p14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-2247" r="-805"/>
          <a:stretch/>
        </p:blipFill>
        <p:spPr>
          <a:xfrm>
            <a:off x="1396993" y="1020516"/>
            <a:ext cx="6658432" cy="5569856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71919A50-1BB0-B844-9942-D35856287487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1B17927E-68C7-1E40-8013-61DAF129A910}"/>
              </a:ext>
            </a:extLst>
          </p:cNvPr>
          <p:cNvSpPr txBox="1"/>
          <p:nvPr/>
        </p:nvSpPr>
        <p:spPr>
          <a:xfrm>
            <a:off x="232228" y="6313450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Google Shape;186;p15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rimary Assessment- ABCDE</a:t>
            </a:r>
            <a:endParaRPr/>
          </a:p>
        </p:txBody>
      </p:sp>
      <p:sp>
        <p:nvSpPr>
          <p:cNvPr id="187" name="Google Shape;187;p15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7064828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r>
              <a:rPr lang="en-US"/>
              <a:t>In patients who are </a:t>
            </a:r>
            <a:r>
              <a:rPr lang="en-US" b="1" u="sng"/>
              <a:t>RESPONSIVE</a:t>
            </a:r>
            <a:r>
              <a:rPr lang="en-US"/>
              <a:t>:</a:t>
            </a:r>
            <a:endParaRPr/>
          </a:p>
          <a:p>
            <a:pPr marL="0" lvl="0" indent="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r>
              <a:rPr lang="en-US"/>
              <a:t>Goal is to identify life threatening conditions using an ordered physical evaluation🡪 </a:t>
            </a:r>
            <a:r>
              <a:rPr lang="en-US">
                <a:solidFill>
                  <a:srgbClr val="FF0000"/>
                </a:solidFill>
              </a:rPr>
              <a:t>ABCDE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A</a:t>
            </a:r>
            <a:r>
              <a:rPr lang="en-US"/>
              <a:t>irway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B</a:t>
            </a:r>
            <a:r>
              <a:rPr lang="en-US"/>
              <a:t>reathing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C</a:t>
            </a:r>
            <a:r>
              <a:rPr lang="en-US"/>
              <a:t>irculation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D</a:t>
            </a:r>
            <a:r>
              <a:rPr lang="en-US"/>
              <a:t>isability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E</a:t>
            </a:r>
            <a:r>
              <a:rPr lang="en-US"/>
              <a:t>xposure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76FBDDA-33CC-2344-AFEA-008FE6539E61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Google Shape;194;p16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Primary Assessment</a:t>
            </a:r>
            <a:endParaRPr/>
          </a:p>
        </p:txBody>
      </p:sp>
      <p:sp>
        <p:nvSpPr>
          <p:cNvPr id="195" name="Google Shape;195;p16"/>
          <p:cNvSpPr txBox="1">
            <a:spLocks noGrp="1"/>
          </p:cNvSpPr>
          <p:nvPr>
            <p:ph type="body" idx="1"/>
          </p:nvPr>
        </p:nvSpPr>
        <p:spPr>
          <a:xfrm>
            <a:off x="1752600" y="1904999"/>
            <a:ext cx="6705600" cy="44788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 dirty="0"/>
              <a:t>In patients who are </a:t>
            </a:r>
            <a:r>
              <a:rPr lang="en-US" b="1" u="sng" dirty="0"/>
              <a:t>UNRESPONSIVE</a:t>
            </a:r>
            <a:r>
              <a:rPr lang="en-US" dirty="0"/>
              <a:t>:</a:t>
            </a:r>
            <a:endParaRPr dirty="0"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rgbClr val="FF0000"/>
              </a:buClr>
              <a:buSzPts val="2400"/>
              <a:buFont typeface="Calibri"/>
              <a:buChar char="–"/>
            </a:pPr>
            <a:r>
              <a:rPr lang="en-US" dirty="0">
                <a:solidFill>
                  <a:srgbClr val="FF0000"/>
                </a:solidFill>
              </a:rPr>
              <a:t>C</a:t>
            </a:r>
            <a:r>
              <a:rPr lang="en-US" dirty="0">
                <a:solidFill>
                  <a:srgbClr val="0C0C0C"/>
                </a:solidFill>
              </a:rPr>
              <a:t>irculation</a:t>
            </a:r>
            <a:endParaRPr dirty="0">
              <a:solidFill>
                <a:srgbClr val="FF0000"/>
              </a:solidFill>
            </a:endParaRPr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rgbClr val="FF0000"/>
              </a:buClr>
              <a:buSzPts val="2400"/>
              <a:buFont typeface="Calibri"/>
              <a:buChar char="–"/>
            </a:pPr>
            <a:r>
              <a:rPr lang="en-US" dirty="0">
                <a:solidFill>
                  <a:srgbClr val="FF0000"/>
                </a:solidFill>
              </a:rPr>
              <a:t>A</a:t>
            </a:r>
            <a:r>
              <a:rPr lang="en-US" dirty="0">
                <a:solidFill>
                  <a:srgbClr val="0C0C0C"/>
                </a:solidFill>
              </a:rPr>
              <a:t>irway</a:t>
            </a:r>
            <a:endParaRPr dirty="0"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rgbClr val="FF0000"/>
              </a:buClr>
              <a:buSzPts val="2400"/>
              <a:buFont typeface="Calibri"/>
              <a:buChar char="–"/>
            </a:pPr>
            <a:r>
              <a:rPr lang="en-US" dirty="0">
                <a:solidFill>
                  <a:srgbClr val="FF0000"/>
                </a:solidFill>
              </a:rPr>
              <a:t>B</a:t>
            </a:r>
            <a:r>
              <a:rPr lang="en-US" dirty="0"/>
              <a:t>reathing</a:t>
            </a:r>
            <a:endParaRPr dirty="0">
              <a:solidFill>
                <a:srgbClr val="0C0C0C"/>
              </a:solidFill>
            </a:endParaRPr>
          </a:p>
          <a:p>
            <a:pPr marL="514350" lvl="0" indent="-457200" algn="l" rtl="0">
              <a:spcBef>
                <a:spcPts val="560"/>
              </a:spcBef>
              <a:spcAft>
                <a:spcPts val="0"/>
              </a:spcAft>
              <a:buClr>
                <a:srgbClr val="FF3300"/>
              </a:buClr>
              <a:buSzPts val="2800"/>
              <a:buFont typeface="Calibri"/>
              <a:buChar char="•"/>
            </a:pPr>
            <a:r>
              <a:rPr lang="en-US" dirty="0">
                <a:solidFill>
                  <a:srgbClr val="FF3300"/>
                </a:solidFill>
              </a:rPr>
              <a:t>Note: </a:t>
            </a:r>
            <a:r>
              <a:rPr lang="en-US" dirty="0"/>
              <a:t>Initial impression assessing consciousness, breathing, and color</a:t>
            </a:r>
            <a:endParaRPr dirty="0"/>
          </a:p>
          <a:p>
            <a:pPr marL="914400" lvl="1" indent="-4572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 dirty="0"/>
              <a:t>If child is unresponsive with no breathing or with gasping:</a:t>
            </a:r>
            <a:endParaRPr dirty="0"/>
          </a:p>
          <a:p>
            <a:pPr marL="1314450" lvl="2" indent="-4572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•"/>
            </a:pPr>
            <a:r>
              <a:rPr lang="en-US" dirty="0"/>
              <a:t>Check pulse; If no pulse:</a:t>
            </a:r>
            <a:endParaRPr dirty="0"/>
          </a:p>
          <a:p>
            <a:pPr marL="1314450" lvl="2" indent="-4572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•"/>
            </a:pPr>
            <a:r>
              <a:rPr lang="en-US" dirty="0"/>
              <a:t>C-A-B CPR (compressions first)</a:t>
            </a:r>
            <a:endParaRPr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03BB593-3268-5A43-A30D-9D25C917A9AE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Google Shape;200;p17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rimary Assessment- Airway</a:t>
            </a:r>
            <a:endParaRPr/>
          </a:p>
        </p:txBody>
      </p:sp>
      <p:sp>
        <p:nvSpPr>
          <p:cNvPr id="201" name="Google Shape;201;p17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683828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 dirty="0"/>
              <a:t>If patient is talking or crying, airway is patent</a:t>
            </a:r>
            <a:endParaRPr dirty="0"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 dirty="0"/>
              <a:t>If obstructed reposition airway (head tilt/chin lift)</a:t>
            </a:r>
            <a:endParaRPr dirty="0"/>
          </a:p>
          <a:p>
            <a:pPr marL="0" lvl="0" indent="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0589B3F-F97F-1044-894E-676F527A4626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Google Shape;208;p18"/>
          <p:cNvSpPr txBox="1">
            <a:spLocks noGrp="1"/>
          </p:cNvSpPr>
          <p:nvPr>
            <p:ph type="title"/>
          </p:nvPr>
        </p:nvSpPr>
        <p:spPr>
          <a:xfrm>
            <a:off x="1752599" y="381000"/>
            <a:ext cx="7028543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rimary Assessment- Breathing</a:t>
            </a:r>
            <a:endParaRPr/>
          </a:p>
        </p:txBody>
      </p:sp>
      <p:pic>
        <p:nvPicPr>
          <p:cNvPr id="211" name="Google Shape;211;p18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475" r="476"/>
          <a:stretch/>
        </p:blipFill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460C3D5-EB77-CB48-A679-CA99B8C82D22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Google Shape;216;p19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Bag-Mask Ventilation</a:t>
            </a:r>
            <a:endParaRPr/>
          </a:p>
        </p:txBody>
      </p:sp>
      <p:sp>
        <p:nvSpPr>
          <p:cNvPr id="217" name="Google Shape;217;p19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Newborn: 1 every second 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Infant: 1 every 3 seconds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Child / Adult: 1 every 5 seconds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CE17CE1-9276-3E43-9375-3CC292F403FC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Google Shape;76;p2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800"/>
              <a:t>5 Steps of Pre-Hospital Provider</a:t>
            </a:r>
            <a:endParaRPr/>
          </a:p>
        </p:txBody>
      </p:sp>
      <p:sp>
        <p:nvSpPr>
          <p:cNvPr id="77" name="Google Shape;77;p2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514350" lvl="0" indent="-51435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AutoNum type="arabicPeriod"/>
            </a:pPr>
            <a:r>
              <a:rPr lang="en-US"/>
              <a:t>Scene size-up</a:t>
            </a:r>
            <a:endParaRPr/>
          </a:p>
          <a:p>
            <a:pPr marL="514350" lvl="0" indent="-51435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AutoNum type="arabicPeriod"/>
            </a:pPr>
            <a:r>
              <a:rPr lang="en-US"/>
              <a:t>Primary (initial) assessment </a:t>
            </a:r>
            <a:endParaRPr/>
          </a:p>
          <a:p>
            <a:pPr marL="514350" lvl="0" indent="-51435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AutoNum type="arabicPeriod"/>
            </a:pPr>
            <a:r>
              <a:rPr lang="en-US"/>
              <a:t>History taking</a:t>
            </a:r>
            <a:endParaRPr/>
          </a:p>
          <a:p>
            <a:pPr marL="514350" lvl="0" indent="-51435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AutoNum type="arabicPeriod"/>
            </a:pPr>
            <a:r>
              <a:rPr lang="en-US"/>
              <a:t>Secondary assessment</a:t>
            </a:r>
            <a:endParaRPr/>
          </a:p>
          <a:p>
            <a:pPr marL="514350" lvl="0" indent="-51435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AutoNum type="arabicPeriod"/>
            </a:pPr>
            <a:r>
              <a:rPr lang="en-US"/>
              <a:t>Re-assessment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D3F5932-02E6-4A4C-B424-4311C61D8932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Google Shape;222;p20"/>
          <p:cNvSpPr txBox="1">
            <a:spLocks noGrp="1"/>
          </p:cNvSpPr>
          <p:nvPr>
            <p:ph type="title"/>
          </p:nvPr>
        </p:nvSpPr>
        <p:spPr>
          <a:xfrm>
            <a:off x="1752599" y="381000"/>
            <a:ext cx="7082971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rimary Assessment- Circulation</a:t>
            </a:r>
            <a:endParaRPr/>
          </a:p>
        </p:txBody>
      </p:sp>
      <p:sp>
        <p:nvSpPr>
          <p:cNvPr id="223" name="Google Shape;223;p20"/>
          <p:cNvSpPr txBox="1">
            <a:spLocks noGrp="1"/>
          </p:cNvSpPr>
          <p:nvPr>
            <p:ph type="body" idx="1"/>
          </p:nvPr>
        </p:nvSpPr>
        <p:spPr>
          <a:xfrm>
            <a:off x="1734458" y="1433285"/>
            <a:ext cx="6705600" cy="52070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•"/>
            </a:pPr>
            <a:r>
              <a:rPr lang="en-US" sz="2200"/>
              <a:t>Pulse quality:</a:t>
            </a:r>
            <a:endParaRPr/>
          </a:p>
          <a:p>
            <a:pPr marL="742950" lvl="1" indent="-28575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–"/>
            </a:pPr>
            <a:r>
              <a:rPr lang="en-US" sz="2200"/>
              <a:t>Brachial/femoral in younger</a:t>
            </a:r>
            <a:endParaRPr/>
          </a:p>
          <a:p>
            <a:pPr marL="742950" lvl="1" indent="-28575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–"/>
            </a:pPr>
            <a:r>
              <a:rPr lang="en-US" sz="2200"/>
              <a:t>Carotid/femoral in older kids,</a:t>
            </a:r>
            <a:endParaRPr/>
          </a:p>
          <a:p>
            <a:pPr marL="457200" lvl="1" indent="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None/>
            </a:pPr>
            <a:r>
              <a:rPr lang="en-US" sz="2200"/>
              <a:t> adults</a:t>
            </a:r>
            <a:endParaRPr/>
          </a:p>
          <a:p>
            <a:pPr marL="342900" lvl="0" indent="-3429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•"/>
            </a:pPr>
            <a:r>
              <a:rPr lang="en-US" sz="2200"/>
              <a:t>Capillary refill:</a:t>
            </a:r>
            <a:endParaRPr/>
          </a:p>
          <a:p>
            <a:pPr marL="742950" lvl="1" indent="-28575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–"/>
            </a:pPr>
            <a:r>
              <a:rPr lang="en-US" sz="2200"/>
              <a:t>Heel or pads of fingertips (nml 2-3 secs)</a:t>
            </a:r>
            <a:endParaRPr/>
          </a:p>
          <a:p>
            <a:pPr marL="342900" lvl="0" indent="-3429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•"/>
            </a:pPr>
            <a:r>
              <a:rPr lang="en-US" sz="2200"/>
              <a:t>Bradycardia🡪 critical hypoxia or ischemia</a:t>
            </a:r>
            <a:endParaRPr/>
          </a:p>
          <a:p>
            <a:pPr marL="342900" lvl="0" indent="-3429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•"/>
            </a:pPr>
            <a:r>
              <a:rPr lang="en-US" sz="2200"/>
              <a:t>Decreased perfusion:</a:t>
            </a:r>
            <a:endParaRPr/>
          </a:p>
          <a:p>
            <a:pPr marL="742950" lvl="1" indent="-28575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–"/>
            </a:pPr>
            <a:r>
              <a:rPr lang="en-US" sz="2200"/>
              <a:t>Extremities become cooler</a:t>
            </a:r>
            <a:endParaRPr/>
          </a:p>
          <a:p>
            <a:pPr marL="342900" lvl="0" indent="-3429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•"/>
            </a:pPr>
            <a:r>
              <a:rPr lang="en-US" sz="2200"/>
              <a:t>Blood pressure</a:t>
            </a:r>
            <a:endParaRPr/>
          </a:p>
          <a:p>
            <a:pPr marL="742950" lvl="1" indent="-28575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Char char="–"/>
            </a:pPr>
            <a:r>
              <a:rPr lang="en-US" sz="2200"/>
              <a:t>Systolic minimum= 70+(2 x age in yrs)</a:t>
            </a:r>
            <a:endParaRPr/>
          </a:p>
          <a:p>
            <a:pPr marL="457200" lvl="1" indent="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Calibri"/>
              <a:buNone/>
            </a:pPr>
            <a:r>
              <a:rPr lang="en-US" sz="2200"/>
              <a:t>for kids &gt; 1yo (&lt;90 in adults)</a:t>
            </a:r>
            <a:endParaRPr/>
          </a:p>
          <a:p>
            <a:pPr marL="457200" lvl="1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/>
          </a:p>
          <a:p>
            <a:pPr marL="457200" lvl="1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943839D-125C-AB42-9D91-07A5F25CF3E4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Google Shape;231;p21"/>
          <p:cNvSpPr txBox="1">
            <a:spLocks noGrp="1"/>
          </p:cNvSpPr>
          <p:nvPr>
            <p:ph type="title"/>
          </p:nvPr>
        </p:nvSpPr>
        <p:spPr>
          <a:xfrm>
            <a:off x="1680028" y="381000"/>
            <a:ext cx="73914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ediatric Assessment- Circulation</a:t>
            </a:r>
            <a:endParaRPr/>
          </a:p>
        </p:txBody>
      </p:sp>
      <p:pic>
        <p:nvPicPr>
          <p:cNvPr id="232" name="Google Shape;232;p21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t="-18570" b="-18569"/>
          <a:stretch/>
        </p:blipFill>
        <p:spPr>
          <a:xfrm>
            <a:off x="1735138" y="1633538"/>
            <a:ext cx="6705600" cy="473392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51C6EC5-6CC5-5444-9044-FB13F6CAB1D4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Google Shape;239;p22"/>
          <p:cNvSpPr txBox="1">
            <a:spLocks noGrp="1"/>
          </p:cNvSpPr>
          <p:nvPr>
            <p:ph type="title"/>
          </p:nvPr>
        </p:nvSpPr>
        <p:spPr>
          <a:xfrm>
            <a:off x="1680028" y="381000"/>
            <a:ext cx="73914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ediatric Assessment- Circulation</a:t>
            </a:r>
            <a:endParaRPr/>
          </a:p>
        </p:txBody>
      </p:sp>
      <p:pic>
        <p:nvPicPr>
          <p:cNvPr id="242" name="Google Shape;242;p22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21" r="22"/>
          <a:stretch/>
        </p:blipFill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7D135DC-FEFA-D34A-831D-902BF9E818A7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Google Shape;247;p23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Circulatory Shock</a:t>
            </a:r>
            <a:endParaRPr/>
          </a:p>
        </p:txBody>
      </p:sp>
      <p:sp>
        <p:nvSpPr>
          <p:cNvPr id="248" name="Google Shape;248;p23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662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r>
              <a:rPr lang="en-US" u="sng"/>
              <a:t>Definition</a:t>
            </a:r>
            <a:r>
              <a:rPr lang="en-US"/>
              <a:t>: poor perfusion to vital organs</a:t>
            </a:r>
            <a:endParaRPr/>
          </a:p>
          <a:p>
            <a:pPr marL="0" lvl="0" indent="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Tachycardia above normal limit for age</a:t>
            </a:r>
            <a:endParaRPr/>
          </a:p>
          <a:p>
            <a:pPr marL="0" lvl="0" indent="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r>
              <a:rPr lang="en-US"/>
              <a:t>		AND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Signs of poor perfusion 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Delay in capillary refill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Altered mental status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Mottled / pale appearance to skin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Decreased urine output</a:t>
            </a:r>
            <a:endParaRPr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BE0A635-AF30-7844-A620-ABB1E6294B99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Google Shape;253;p24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Circulatory Shock- Types</a:t>
            </a:r>
            <a:endParaRPr/>
          </a:p>
        </p:txBody>
      </p:sp>
      <p:sp>
        <p:nvSpPr>
          <p:cNvPr id="254" name="Google Shape;254;p24"/>
          <p:cNvSpPr txBox="1">
            <a:spLocks noGrp="1"/>
          </p:cNvSpPr>
          <p:nvPr>
            <p:ph type="body" idx="1"/>
          </p:nvPr>
        </p:nvSpPr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Septic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Hypovolemic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Hemorrhagic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Cardiogenic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6C7B75F-CBC6-7145-8A83-3995CF6D8972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Google Shape;260;p25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Circulatory Shock- Treatment</a:t>
            </a:r>
            <a:endParaRPr/>
          </a:p>
        </p:txBody>
      </p:sp>
      <p:sp>
        <p:nvSpPr>
          <p:cNvPr id="261" name="Google Shape;261;p25"/>
          <p:cNvSpPr txBox="1">
            <a:spLocks noGrp="1"/>
          </p:cNvSpPr>
          <p:nvPr>
            <p:ph type="body" idx="1"/>
          </p:nvPr>
        </p:nvSpPr>
        <p:spPr>
          <a:xfrm>
            <a:off x="1752600" y="1701803"/>
            <a:ext cx="6705600" cy="49530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Isotonic Fluid 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Normal Saline / Lactated Ringers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Paediatric: 20ml / kg push (&lt; 15min) and reassess 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Adult: 1L push (&lt;15 min) and reassess</a:t>
            </a:r>
            <a:endParaRPr/>
          </a:p>
          <a:p>
            <a:pPr marL="57150" lvl="0" indent="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514350" lvl="0" indent="-4572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Pushing fluids in &lt; 15 min</a:t>
            </a:r>
            <a:endParaRPr/>
          </a:p>
          <a:p>
            <a:pPr marL="914400" lvl="1" indent="-4572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Pull up in 20 ml syringe</a:t>
            </a:r>
            <a:endParaRPr/>
          </a:p>
          <a:p>
            <a:pPr marL="914400" lvl="1" indent="-4572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BP cuff around fluid bag</a:t>
            </a:r>
            <a:endParaRPr/>
          </a:p>
          <a:p>
            <a:pPr marL="914400" lvl="1" indent="-4572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REASSESS. Vitals and pulmonary auscultation to check for fluid overload </a:t>
            </a:r>
            <a:endParaRPr/>
          </a:p>
          <a:p>
            <a:pPr marL="742950" lvl="1" indent="-1333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F36D4D7-6A60-3948-AC57-12A908B85009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Google Shape;266;p26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8834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rimary Assessment:- Disability</a:t>
            </a:r>
            <a:endParaRPr/>
          </a:p>
        </p:txBody>
      </p:sp>
      <p:sp>
        <p:nvSpPr>
          <p:cNvPr id="267" name="Google Shape;267;p26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Neurologic status of the patient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Identifying severe neurologic compromise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AVPU vs GCS 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AVPU (Alert, Voice, Pain, Unresponsive)</a:t>
            </a:r>
            <a:endParaRPr/>
          </a:p>
          <a:p>
            <a:pPr marL="1143000" lvl="2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•"/>
            </a:pPr>
            <a:r>
              <a:rPr lang="en-US"/>
              <a:t>Categorizes based on motor response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GCS (Glascow Coma Scale)</a:t>
            </a:r>
            <a:endParaRPr/>
          </a:p>
          <a:p>
            <a:pPr marL="1143000" lvl="2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Char char="•"/>
            </a:pPr>
            <a:r>
              <a:rPr lang="en-US"/>
              <a:t>Helps to categorize patient’s neurologic status based on motor movement, eye opening and verbal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Pupil reactivity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88860F6-0232-5E45-B12E-6387E611ACBF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Google Shape;275;p27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AVPU</a:t>
            </a:r>
            <a:endParaRPr/>
          </a:p>
        </p:txBody>
      </p:sp>
      <p:pic>
        <p:nvPicPr>
          <p:cNvPr id="278" name="Google Shape;278;p27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-19945" r="-19945"/>
          <a:stretch/>
        </p:blipFill>
        <p:spPr>
          <a:xfrm>
            <a:off x="1752600" y="1905000"/>
            <a:ext cx="6705600" cy="41910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6F7CE13-8C1A-574D-9C20-8CFE7E98C724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9E3EAA09-00A6-8149-A99C-34881953435F}"/>
              </a:ext>
            </a:extLst>
          </p:cNvPr>
          <p:cNvSpPr txBox="1"/>
          <p:nvPr/>
        </p:nvSpPr>
        <p:spPr>
          <a:xfrm>
            <a:off x="232228" y="6313450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Google Shape;283;p28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GCS</a:t>
            </a:r>
            <a:endParaRPr/>
          </a:p>
        </p:txBody>
      </p:sp>
      <p:pic>
        <p:nvPicPr>
          <p:cNvPr id="286" name="Google Shape;286;p28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-36873" r="-36873"/>
          <a:stretch/>
        </p:blipFill>
        <p:spPr>
          <a:xfrm>
            <a:off x="1752600" y="1288143"/>
            <a:ext cx="6705600" cy="5297714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78310F2-9585-AF4F-A349-12E3437BF2DF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BCD4B4CF-5B0C-F44C-9C28-5B0549DF3C31}"/>
              </a:ext>
            </a:extLst>
          </p:cNvPr>
          <p:cNvSpPr txBox="1"/>
          <p:nvPr/>
        </p:nvSpPr>
        <p:spPr>
          <a:xfrm>
            <a:off x="143020" y="6313450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Google Shape;291;p29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rimary Assessment- Exposure</a:t>
            </a:r>
            <a:endParaRPr/>
          </a:p>
        </p:txBody>
      </p:sp>
      <p:sp>
        <p:nvSpPr>
          <p:cNvPr id="292" name="Google Shape;292;p29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Proper exposure is necessary to evaluate physiologic function and identify anatomical abnormalitie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Maintain warm, ambient environment and minimize heat los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Monitor temperature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Warm IV fluids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0697AE8-2D6B-1C4E-A8E2-B6DD700F733C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3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Scene Size-Up</a:t>
            </a:r>
            <a:endParaRPr/>
          </a:p>
        </p:txBody>
      </p:sp>
      <p:pic>
        <p:nvPicPr>
          <p:cNvPr id="85" name="Google Shape;85;p3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3320" t="-1466" r="1244" b="-4446"/>
          <a:stretch/>
        </p:blipFill>
        <p:spPr>
          <a:xfrm>
            <a:off x="3011714" y="1505857"/>
            <a:ext cx="4172857" cy="5352143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71991D7-7C2C-944D-88F2-716EAF8E801D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3103960F-864F-EE4D-B6D7-85341FFA67FC}"/>
              </a:ext>
            </a:extLst>
          </p:cNvPr>
          <p:cNvSpPr txBox="1"/>
          <p:nvPr/>
        </p:nvSpPr>
        <p:spPr>
          <a:xfrm>
            <a:off x="232228" y="6227027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Google Shape;299;p30"/>
          <p:cNvSpPr txBox="1">
            <a:spLocks noGrp="1"/>
          </p:cNvSpPr>
          <p:nvPr>
            <p:ph type="title"/>
          </p:nvPr>
        </p:nvSpPr>
        <p:spPr>
          <a:xfrm>
            <a:off x="1774901" y="48911"/>
            <a:ext cx="6705600" cy="11792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 dirty="0"/>
              <a:t>Primary Assessment- </a:t>
            </a:r>
            <a:br>
              <a:rPr lang="en-US" sz="4000" dirty="0"/>
            </a:br>
            <a:r>
              <a:rPr lang="en-US" sz="4000" dirty="0"/>
              <a:t>Transport Decision</a:t>
            </a:r>
            <a:endParaRPr dirty="0"/>
          </a:p>
        </p:txBody>
      </p:sp>
      <p:pic>
        <p:nvPicPr>
          <p:cNvPr id="300" name="Google Shape;300;p30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-5406" t="723" r="-8494" b="361"/>
          <a:stretch/>
        </p:blipFill>
        <p:spPr>
          <a:xfrm>
            <a:off x="2451629" y="1228197"/>
            <a:ext cx="5352143" cy="4970463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8E6AF2AD-C1A5-1346-8FED-7B74BC591C52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7E23B26F-0FE8-A244-9B09-4D47F3B51694}"/>
              </a:ext>
            </a:extLst>
          </p:cNvPr>
          <p:cNvSpPr txBox="1"/>
          <p:nvPr/>
        </p:nvSpPr>
        <p:spPr>
          <a:xfrm>
            <a:off x="246743" y="6198660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Google Shape;307;p31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792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rimary Assessment- </a:t>
            </a:r>
            <a:br>
              <a:rPr lang="en-US" sz="4000"/>
            </a:br>
            <a:r>
              <a:rPr lang="en-US" sz="4000"/>
              <a:t>Transport Decision</a:t>
            </a:r>
            <a:endParaRPr/>
          </a:p>
        </p:txBody>
      </p:sp>
      <p:sp>
        <p:nvSpPr>
          <p:cNvPr id="308" name="Google Shape;308;p31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What is the expected benefit of treatment?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EMS system regulations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Basic or advanced team?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Comfort level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Transport time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09EB5DA-0FD7-1B45-B519-AB9F9A77158E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Google Shape;315;p32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History Taking</a:t>
            </a:r>
            <a:endParaRPr/>
          </a:p>
        </p:txBody>
      </p:sp>
      <p:pic>
        <p:nvPicPr>
          <p:cNvPr id="316" name="Google Shape;316;p32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-1728" t="1" r="667" b="-724"/>
          <a:stretch/>
        </p:blipFill>
        <p:spPr>
          <a:xfrm>
            <a:off x="2449286" y="1187489"/>
            <a:ext cx="4245428" cy="5043033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E7ABD2D-9720-FB49-B4C9-E683CE3C5F25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89BF1813-28AD-5945-840E-FBAD5D4E2412}"/>
              </a:ext>
            </a:extLst>
          </p:cNvPr>
          <p:cNvSpPr txBox="1"/>
          <p:nvPr/>
        </p:nvSpPr>
        <p:spPr>
          <a:xfrm>
            <a:off x="232228" y="6313450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Google Shape;323;p33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History Taking</a:t>
            </a:r>
            <a:endParaRPr/>
          </a:p>
        </p:txBody>
      </p:sp>
      <p:sp>
        <p:nvSpPr>
          <p:cNvPr id="324" name="Google Shape;324;p33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To obtain a complete description of the main complaint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To determine the mechanism of injury or circumstance of illnes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S.A.M.P.L.E.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C052C7A-2248-554A-A0E2-3D492AC5416B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Google Shape;331;p34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History Taking- </a:t>
            </a:r>
            <a:r>
              <a:rPr lang="en-US" sz="4000">
                <a:solidFill>
                  <a:srgbClr val="FF0000"/>
                </a:solidFill>
              </a:rPr>
              <a:t>“S.A.M.P.L.E”</a:t>
            </a:r>
            <a:endParaRPr sz="4000"/>
          </a:p>
        </p:txBody>
      </p:sp>
      <p:sp>
        <p:nvSpPr>
          <p:cNvPr id="332" name="Google Shape;332;p34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S</a:t>
            </a:r>
            <a:r>
              <a:rPr lang="en-US"/>
              <a:t>igns/ Symptom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A</a:t>
            </a:r>
            <a:r>
              <a:rPr lang="en-US"/>
              <a:t>llergie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M</a:t>
            </a:r>
            <a:r>
              <a:rPr lang="en-US"/>
              <a:t>edication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P</a:t>
            </a:r>
            <a:r>
              <a:rPr lang="en-US"/>
              <a:t>ast medical problem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L</a:t>
            </a:r>
            <a:r>
              <a:rPr lang="en-US"/>
              <a:t>ast food or liquid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E</a:t>
            </a:r>
            <a:r>
              <a:rPr lang="en-US"/>
              <a:t>vents leading to injury or illness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7A75D11-D4AB-4543-A92F-AE8C3DD9ABC2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Google Shape;339;p35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Secondary Assessment</a:t>
            </a:r>
            <a:endParaRPr/>
          </a:p>
        </p:txBody>
      </p:sp>
      <p:pic>
        <p:nvPicPr>
          <p:cNvPr id="340" name="Google Shape;340;p35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-1741" t="-2861" r="-95" b="1067"/>
          <a:stretch/>
        </p:blipFill>
        <p:spPr>
          <a:xfrm>
            <a:off x="2432960" y="1176896"/>
            <a:ext cx="4245427" cy="5188857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CA5D34A1-5000-D249-9EAD-49CBD260BDD8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4553982E-7F4B-9548-A118-500BA85155F3}"/>
              </a:ext>
            </a:extLst>
          </p:cNvPr>
          <p:cNvSpPr txBox="1"/>
          <p:nvPr/>
        </p:nvSpPr>
        <p:spPr>
          <a:xfrm>
            <a:off x="232228" y="6313450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Google Shape;347;p36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Secondary Assessment: Physical Exam</a:t>
            </a:r>
            <a:endParaRPr/>
          </a:p>
        </p:txBody>
      </p:sp>
      <p:sp>
        <p:nvSpPr>
          <p:cNvPr id="348" name="Google Shape;348;p36"/>
          <p:cNvSpPr txBox="1">
            <a:spLocks noGrp="1"/>
          </p:cNvSpPr>
          <p:nvPr>
            <p:ph type="body" idx="1"/>
          </p:nvPr>
        </p:nvSpPr>
        <p:spPr>
          <a:xfrm>
            <a:off x="1734457" y="1632858"/>
            <a:ext cx="6919685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Often not possible due to need for transport and treatment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General observation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Skin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Head, eyes, ears, nose, throat, mouth, neck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Chest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Abdomen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Back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Extremities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BAE3E91-BC89-594D-8EBA-7A51F3ADD8CF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Google Shape;355;p37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Monitoring Devices</a:t>
            </a:r>
            <a:endParaRPr/>
          </a:p>
        </p:txBody>
      </p:sp>
      <p:pic>
        <p:nvPicPr>
          <p:cNvPr id="358" name="Google Shape;358;p37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152" r="-2062" b="1074"/>
          <a:stretch/>
        </p:blipFill>
        <p:spPr>
          <a:xfrm>
            <a:off x="2331357" y="1360714"/>
            <a:ext cx="4481286" cy="5006748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023E577-3480-334B-95B9-0534ED26BDA6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6AA874FA-032B-684B-9490-1A403DBF3FF7}"/>
              </a:ext>
            </a:extLst>
          </p:cNvPr>
          <p:cNvSpPr txBox="1"/>
          <p:nvPr/>
        </p:nvSpPr>
        <p:spPr>
          <a:xfrm>
            <a:off x="232228" y="6313450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Google Shape;363;p38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Monitoring Devices</a:t>
            </a:r>
            <a:endParaRPr/>
          </a:p>
        </p:txBody>
      </p:sp>
      <p:sp>
        <p:nvSpPr>
          <p:cNvPr id="364" name="Google Shape;364;p38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Pulse oximetry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Excellent tool to assess how patient is breathing</a:t>
            </a:r>
            <a:endParaRPr/>
          </a:p>
          <a:p>
            <a:pPr marL="457200" lvl="1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r>
              <a:rPr lang="en-US"/>
              <a:t>&gt;94% = Good oxygenation</a:t>
            </a:r>
            <a:endParaRPr/>
          </a:p>
          <a:p>
            <a:pPr marL="0" lvl="0" indent="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Additional devices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Rapid glucose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ECG</a:t>
            </a:r>
            <a:endParaRPr/>
          </a:p>
          <a:p>
            <a:pPr marL="457200" lvl="1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/>
          </a:p>
          <a:p>
            <a:pPr marL="457200" lvl="1" indent="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</a:pP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68275F9-297A-5342-8FDF-E9A606294143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Google Shape;371;p39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Reassessment</a:t>
            </a:r>
            <a:endParaRPr/>
          </a:p>
        </p:txBody>
      </p:sp>
      <p:pic>
        <p:nvPicPr>
          <p:cNvPr id="374" name="Google Shape;374;p39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429" r="-3013" b="359"/>
          <a:stretch/>
        </p:blipFill>
        <p:spPr>
          <a:xfrm>
            <a:off x="2626555" y="1360714"/>
            <a:ext cx="4336143" cy="5024891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7BFC1F13-15E2-1949-8153-8BC4CD651810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3DF646C4-6953-554A-8E54-0247B58DB9AE}"/>
              </a:ext>
            </a:extLst>
          </p:cNvPr>
          <p:cNvSpPr txBox="1"/>
          <p:nvPr/>
        </p:nvSpPr>
        <p:spPr>
          <a:xfrm>
            <a:off x="232228" y="6313450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61B7BE9-5766-C442-8935-4F06281F7BA9}"/>
              </a:ext>
            </a:extLst>
          </p:cNvPr>
          <p:cNvSpPr txBox="1"/>
          <p:nvPr/>
        </p:nvSpPr>
        <p:spPr>
          <a:xfrm>
            <a:off x="7181385" y="8051180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4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Scene Size-Up</a:t>
            </a:r>
            <a:endParaRPr/>
          </a:p>
        </p:txBody>
      </p:sp>
      <p:sp>
        <p:nvSpPr>
          <p:cNvPr id="92" name="Google Shape;92;p4"/>
          <p:cNvSpPr txBox="1">
            <a:spLocks noGrp="1"/>
          </p:cNvSpPr>
          <p:nvPr>
            <p:ph type="body" idx="1"/>
          </p:nvPr>
        </p:nvSpPr>
        <p:spPr>
          <a:xfrm>
            <a:off x="1734458" y="1469571"/>
            <a:ext cx="6705600" cy="52251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Prepare mentally to approach and treat a child or adult and interact with the family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What specific equipment and medications do I need? Need additional resources?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Will have to do an age appropriate assessment?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Identify any possible safety threats to: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Patient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Caregiver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By-standards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You!!!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897BE9D-618F-A845-B55D-82D72BCF3C67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9" name="Google Shape;379;p40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Reassessment</a:t>
            </a:r>
            <a:endParaRPr/>
          </a:p>
        </p:txBody>
      </p:sp>
      <p:sp>
        <p:nvSpPr>
          <p:cNvPr id="380" name="Google Shape;380;p40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ABCDE w/ repeat vital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Assessment of positive anatomic feature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Review of effectiveness of safety of treatment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Radio reporting: 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Updates communicated to A &amp; E</a:t>
            </a:r>
            <a:endParaRPr/>
          </a:p>
          <a:p>
            <a:pPr marL="742950" lvl="1" indent="-28575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Char char="–"/>
            </a:pPr>
            <a:r>
              <a:rPr lang="en-US"/>
              <a:t>Estimate of arrival time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6751EA2-5379-3F40-909A-C59C4E218552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5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rimary Assessment</a:t>
            </a:r>
            <a:endParaRPr/>
          </a:p>
        </p:txBody>
      </p:sp>
      <p:pic>
        <p:nvPicPr>
          <p:cNvPr id="103" name="Google Shape;103;p5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6712" t="2243" r="7045" b="2242"/>
          <a:stretch/>
        </p:blipFill>
        <p:spPr>
          <a:xfrm>
            <a:off x="2830286" y="1324430"/>
            <a:ext cx="4662714" cy="540657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C087A940-7577-E845-85DD-86A805EC2957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BCC67D96-4944-D440-BBAB-4D1496247373}"/>
              </a:ext>
            </a:extLst>
          </p:cNvPr>
          <p:cNvSpPr txBox="1"/>
          <p:nvPr/>
        </p:nvSpPr>
        <p:spPr>
          <a:xfrm>
            <a:off x="232228" y="6227027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Google Shape;109;p6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Primary Assessment</a:t>
            </a:r>
            <a:endParaRPr/>
          </a:p>
        </p:txBody>
      </p:sp>
      <p:pic>
        <p:nvPicPr>
          <p:cNvPr id="110" name="Google Shape;110;p6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t="-8257" b="-8256"/>
          <a:stretch/>
        </p:blipFill>
        <p:spPr>
          <a:xfrm>
            <a:off x="1735138" y="1633538"/>
            <a:ext cx="6705600" cy="473392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29B49B4-B562-2141-9A4B-8AD5A843C599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10">
            <a:extLst>
              <a:ext uri="{FF2B5EF4-FFF2-40B4-BE49-F238E27FC236}">
                <a16:creationId xmlns:a16="http://schemas.microsoft.com/office/drawing/2014/main" id="{021E2BAE-B916-EF4E-8670-63C5C1C68776}"/>
              </a:ext>
            </a:extLst>
          </p:cNvPr>
          <p:cNvSpPr txBox="1"/>
          <p:nvPr/>
        </p:nvSpPr>
        <p:spPr>
          <a:xfrm>
            <a:off x="232228" y="6227027"/>
            <a:ext cx="3011714" cy="49994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0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://www.peppsite.com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7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Initial Assessment</a:t>
            </a:r>
            <a:endParaRPr/>
          </a:p>
        </p:txBody>
      </p:sp>
      <p:sp>
        <p:nvSpPr>
          <p:cNvPr id="118" name="Google Shape;118;p7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Allows examiner to quickly obtain critical information about the patient before touching the patient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Helps set priorities for the rest of the hands on primary assessment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D46794F-281E-5340-BE28-E70E14A5C5D8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p8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1143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Appearance</a:t>
            </a:r>
            <a:endParaRPr/>
          </a:p>
        </p:txBody>
      </p:sp>
      <p:sp>
        <p:nvSpPr>
          <p:cNvPr id="129" name="Google Shape;129;p8"/>
          <p:cNvSpPr txBox="1">
            <a:spLocks noGrp="1"/>
          </p:cNvSpPr>
          <p:nvPr>
            <p:ph type="body" idx="1"/>
          </p:nvPr>
        </p:nvSpPr>
        <p:spPr>
          <a:xfrm>
            <a:off x="1698171" y="1560285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342900" lvl="0" indent="-342900" algn="l" rtl="0">
              <a:spcBef>
                <a:spcPts val="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T</a:t>
            </a:r>
            <a:r>
              <a:rPr lang="en-US"/>
              <a:t>one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I</a:t>
            </a:r>
            <a:r>
              <a:rPr lang="en-US"/>
              <a:t>nteractive 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C</a:t>
            </a:r>
            <a:r>
              <a:rPr lang="en-US"/>
              <a:t>onsolability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L</a:t>
            </a:r>
            <a:r>
              <a:rPr lang="en-US"/>
              <a:t>ook/gaze</a:t>
            </a:r>
            <a:endParaRPr/>
          </a:p>
          <a:p>
            <a:pPr marL="342900" lvl="0" indent="-1651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rgbClr val="FF0000"/>
              </a:buClr>
              <a:buSzPts val="2800"/>
              <a:buFont typeface="Calibri"/>
              <a:buChar char="•"/>
            </a:pPr>
            <a:r>
              <a:rPr lang="en-US">
                <a:solidFill>
                  <a:srgbClr val="FF0000"/>
                </a:solidFill>
              </a:rPr>
              <a:t>S</a:t>
            </a:r>
            <a:r>
              <a:rPr lang="en-US"/>
              <a:t>peech/cry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CDE3601-82EA-6E4A-962E-D2D32DE42162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p9"/>
          <p:cNvSpPr txBox="1"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/>
              <a:t>Appearance</a:t>
            </a:r>
            <a:endParaRPr/>
          </a:p>
        </p:txBody>
      </p:sp>
      <p:sp>
        <p:nvSpPr>
          <p:cNvPr id="135" name="Google Shape;135;p9"/>
          <p:cNvSpPr txBox="1">
            <a:spLocks noGrp="1"/>
          </p:cNvSpPr>
          <p:nvPr>
            <p:ph type="body" idx="1"/>
          </p:nvPr>
        </p:nvSpPr>
        <p:spPr>
          <a:xfrm>
            <a:off x="1734458" y="1632858"/>
            <a:ext cx="6705600" cy="4735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None/>
            </a:pPr>
            <a:r>
              <a:rPr lang="en-US"/>
              <a:t>Key points to remember: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Observe initially from across the room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Use distraction tool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Patients with abnormal appearance are seriously ill and may need immediate life support efforts</a:t>
            </a:r>
            <a:endParaRPr/>
          </a:p>
          <a:p>
            <a:pPr marL="342900" lvl="0" indent="-3429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Calibri"/>
              <a:buChar char="•"/>
            </a:pPr>
            <a:r>
              <a:rPr lang="en-US"/>
              <a:t>Infant making eye contact is usually a sign of a relatively healthy child</a:t>
            </a:r>
            <a:endParaRPr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16BF37F-CFFE-8F43-A3D1-CE781E65098E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9</TotalTime>
  <Words>1145</Words>
  <Application>Microsoft Macintosh PowerPoint</Application>
  <PresentationFormat>On-screen Show (4:3)</PresentationFormat>
  <Paragraphs>242</Paragraphs>
  <Slides>40</Slides>
  <Notes>4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0</vt:i4>
      </vt:variant>
    </vt:vector>
  </HeadingPairs>
  <TitlesOfParts>
    <vt:vector size="43" baseType="lpstr">
      <vt:lpstr>Arial</vt:lpstr>
      <vt:lpstr>Calibri</vt:lpstr>
      <vt:lpstr>Blank Presentation</vt:lpstr>
      <vt:lpstr>EMS- Pediatric Assessment</vt:lpstr>
      <vt:lpstr>5 Steps of Pre-Hospital Provider</vt:lpstr>
      <vt:lpstr>Scene Size-Up</vt:lpstr>
      <vt:lpstr>Scene Size-Up</vt:lpstr>
      <vt:lpstr>Primary Assessment</vt:lpstr>
      <vt:lpstr>Primary Assessment</vt:lpstr>
      <vt:lpstr>Initial Assessment</vt:lpstr>
      <vt:lpstr>Appearance</vt:lpstr>
      <vt:lpstr>Appearance</vt:lpstr>
      <vt:lpstr>Breathing</vt:lpstr>
      <vt:lpstr>Breathing/Sniffing Position</vt:lpstr>
      <vt:lpstr>Breathing/ Retractions</vt:lpstr>
      <vt:lpstr>Circulation</vt:lpstr>
      <vt:lpstr>Primary Assessment- Hands On</vt:lpstr>
      <vt:lpstr>Primary Assessment- ABCDE</vt:lpstr>
      <vt:lpstr>Primary Assessment</vt:lpstr>
      <vt:lpstr>Primary Assessment- Airway</vt:lpstr>
      <vt:lpstr>Primary Assessment- Breathing</vt:lpstr>
      <vt:lpstr>Bag-Mask Ventilation</vt:lpstr>
      <vt:lpstr>Primary Assessment- Circulation</vt:lpstr>
      <vt:lpstr>Pediatric Assessment- Circulation</vt:lpstr>
      <vt:lpstr>Pediatric Assessment- Circulation</vt:lpstr>
      <vt:lpstr>Circulatory Shock</vt:lpstr>
      <vt:lpstr>Circulatory Shock- Types</vt:lpstr>
      <vt:lpstr>Circulatory Shock- Treatment</vt:lpstr>
      <vt:lpstr>Primary Assessment:- Disability</vt:lpstr>
      <vt:lpstr>AVPU</vt:lpstr>
      <vt:lpstr>GCS</vt:lpstr>
      <vt:lpstr>Primary Assessment- Exposure</vt:lpstr>
      <vt:lpstr>Primary Assessment-  Transport Decision</vt:lpstr>
      <vt:lpstr>Primary Assessment-  Transport Decision</vt:lpstr>
      <vt:lpstr>History Taking</vt:lpstr>
      <vt:lpstr>History Taking</vt:lpstr>
      <vt:lpstr>History Taking- “S.A.M.P.L.E”</vt:lpstr>
      <vt:lpstr>Secondary Assessment</vt:lpstr>
      <vt:lpstr>Secondary Assessment: Physical Exam</vt:lpstr>
      <vt:lpstr>Monitoring Devices</vt:lpstr>
      <vt:lpstr>Monitoring Devices</vt:lpstr>
      <vt:lpstr>Reassessment</vt:lpstr>
      <vt:lpstr>Reassessme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MS- Pediatric Assessment</dc:title>
  <dc:creator>DeeDee Tomkins</dc:creator>
  <cp:lastModifiedBy>Alisa Wray</cp:lastModifiedBy>
  <cp:revision>8</cp:revision>
  <dcterms:created xsi:type="dcterms:W3CDTF">2010-10-06T19:04:54Z</dcterms:created>
  <dcterms:modified xsi:type="dcterms:W3CDTF">2021-07-16T01:09:59Z</dcterms:modified>
</cp:coreProperties>
</file>